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559675" cy="10691813"/>
  <p:notesSz cx="6800850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83716-B702-4006-8DB7-CF178399DA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4008F5-494F-4A5B-A32E-77B63B8DEB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9EA368-1E18-4DF9-ADDA-9716041D9A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67840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979160" y="249516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80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67840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979160" y="6180120"/>
            <a:ext cx="21906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70A14-5600-4C79-A336-438410A6C3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D267B-81A4-4E8D-8196-92CACE7EA4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9CE04-8E84-4F08-A8F9-C4FD16DFB1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12C65-AC45-4F9F-9E3B-17695B9399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443AC-D473-4FB4-9233-D0799C5178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78000" y="428400"/>
            <a:ext cx="6804000" cy="8256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468FC7-2D83-45D2-A13D-7D4F6C3A00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DBE7AE-DA28-4541-A565-921DF854D9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864600" y="618012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C94C1-528B-41DB-BD18-C8706261E4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80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864600" y="2495160"/>
            <a:ext cx="332028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8000" y="6180120"/>
            <a:ext cx="6804000" cy="336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F3CDE4-EDD3-4BD4-9F22-9EAFC6035F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78000" y="428400"/>
            <a:ext cx="6804000" cy="1780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78000" y="2495160"/>
            <a:ext cx="6804000" cy="7054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77640" y="9909000"/>
            <a:ext cx="176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582640" y="9909000"/>
            <a:ext cx="239364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418000" y="9909000"/>
            <a:ext cx="1764000" cy="57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Arial"/>
                <a:ea typeface="MS PGothic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D65BFAC-37ED-4256-8F94-808600D0D582}" type="slidenum">
              <a:rPr b="0" lang="en-US" sz="1200" spc="-1" strike="noStrike">
                <a:solidFill>
                  <a:srgbClr val="898989"/>
                </a:solidFill>
                <a:latin typeface="Arial"/>
                <a:ea typeface="MS PGothic"/>
              </a:rPr>
              <a:t>&lt;number&gt;</a:t>
            </a:fld>
            <a:endParaRPr b="0" lang="en-US" sz="12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F:\co-occurrence\version2\additional_figurs\heatmap_mouse_all.png"/>
          <p:cNvPicPr/>
          <p:nvPr/>
        </p:nvPicPr>
        <p:blipFill>
          <a:blip r:embed="rId1"/>
          <a:stretch/>
        </p:blipFill>
        <p:spPr>
          <a:xfrm>
            <a:off x="3780000" y="1170000"/>
            <a:ext cx="3024000" cy="30240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F:\co-occurrence\version2\additional_figurs\heatmap_mouse_CpG.png"/>
          <p:cNvPicPr/>
          <p:nvPr/>
        </p:nvPicPr>
        <p:blipFill>
          <a:blip r:embed="rId2"/>
          <a:stretch/>
        </p:blipFill>
        <p:spPr>
          <a:xfrm>
            <a:off x="3780000" y="4272120"/>
            <a:ext cx="3024000" cy="3024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" descr="F:\co-occurrence\version2\additional_figurs\heatmap_mouse_nonCpG.png"/>
          <p:cNvPicPr/>
          <p:nvPr/>
        </p:nvPicPr>
        <p:blipFill>
          <a:blip r:embed="rId3"/>
          <a:stretch/>
        </p:blipFill>
        <p:spPr>
          <a:xfrm>
            <a:off x="3780000" y="7434360"/>
            <a:ext cx="3024000" cy="302400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5" descr="F:\co-occurrence\version2\additional_figurs\heatmap_human_all.png"/>
          <p:cNvPicPr/>
          <p:nvPr/>
        </p:nvPicPr>
        <p:blipFill>
          <a:blip r:embed="rId4"/>
          <a:stretch/>
        </p:blipFill>
        <p:spPr>
          <a:xfrm>
            <a:off x="395280" y="1170000"/>
            <a:ext cx="3024360" cy="30240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F:\co-occurrence\version2\additional_figurs\heatmap_human_CpG.png"/>
          <p:cNvPicPr/>
          <p:nvPr/>
        </p:nvPicPr>
        <p:blipFill>
          <a:blip r:embed="rId5"/>
          <a:stretch/>
        </p:blipFill>
        <p:spPr>
          <a:xfrm>
            <a:off x="395280" y="4272120"/>
            <a:ext cx="3024360" cy="30240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7" descr="F:\co-occurrence\version2\additional_figurs\heatmap_human_nonCpG.png"/>
          <p:cNvPicPr/>
          <p:nvPr/>
        </p:nvPicPr>
        <p:blipFill>
          <a:blip r:embed="rId6"/>
          <a:stretch/>
        </p:blipFill>
        <p:spPr>
          <a:xfrm>
            <a:off x="395280" y="7434360"/>
            <a:ext cx="3024360" cy="3024000"/>
          </a:xfrm>
          <a:prstGeom prst="rect">
            <a:avLst/>
          </a:prstGeom>
          <a:ln w="0">
            <a:noFill/>
          </a:ln>
        </p:spPr>
      </p:pic>
      <p:sp>
        <p:nvSpPr>
          <p:cNvPr id="47" name="テキスト ボックス 8"/>
          <p:cNvSpPr/>
          <p:nvPr/>
        </p:nvSpPr>
        <p:spPr>
          <a:xfrm>
            <a:off x="254520" y="7099200"/>
            <a:ext cx="38340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E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テキスト ボックス 9"/>
          <p:cNvSpPr/>
          <p:nvPr/>
        </p:nvSpPr>
        <p:spPr>
          <a:xfrm>
            <a:off x="3661560" y="7099200"/>
            <a:ext cx="36648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F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9" name="テキスト ボックス 8"/>
          <p:cNvSpPr/>
          <p:nvPr/>
        </p:nvSpPr>
        <p:spPr>
          <a:xfrm>
            <a:off x="254520" y="88092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A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テキスト ボックス 9"/>
          <p:cNvSpPr/>
          <p:nvPr/>
        </p:nvSpPr>
        <p:spPr>
          <a:xfrm>
            <a:off x="3663000" y="88092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B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テキスト ボックス 8"/>
          <p:cNvSpPr/>
          <p:nvPr/>
        </p:nvSpPr>
        <p:spPr>
          <a:xfrm>
            <a:off x="254520" y="393876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C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テキスト ボックス 9"/>
          <p:cNvSpPr/>
          <p:nvPr/>
        </p:nvSpPr>
        <p:spPr>
          <a:xfrm>
            <a:off x="3663000" y="3938760"/>
            <a:ext cx="400320" cy="43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MS PGothic"/>
              </a:rPr>
              <a:t>D</a:t>
            </a: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Rectangle 14"/>
          <p:cNvSpPr/>
          <p:nvPr/>
        </p:nvSpPr>
        <p:spPr>
          <a:xfrm>
            <a:off x="3995640" y="42559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TextBox 14"/>
          <p:cNvSpPr/>
          <p:nvPr/>
        </p:nvSpPr>
        <p:spPr>
          <a:xfrm>
            <a:off x="4356000" y="7068960"/>
            <a:ext cx="21211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TextBox 19"/>
          <p:cNvSpPr/>
          <p:nvPr/>
        </p:nvSpPr>
        <p:spPr>
          <a:xfrm rot="16200000">
            <a:off x="2545200" y="55774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Rectangle 17"/>
          <p:cNvSpPr/>
          <p:nvPr/>
        </p:nvSpPr>
        <p:spPr>
          <a:xfrm>
            <a:off x="611280" y="42559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TextBox 14"/>
          <p:cNvSpPr/>
          <p:nvPr/>
        </p:nvSpPr>
        <p:spPr>
          <a:xfrm>
            <a:off x="971640" y="7068960"/>
            <a:ext cx="212076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TextBox 19"/>
          <p:cNvSpPr/>
          <p:nvPr/>
        </p:nvSpPr>
        <p:spPr>
          <a:xfrm rot="16200000">
            <a:off x="-838800" y="55774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Rectangle 20"/>
          <p:cNvSpPr/>
          <p:nvPr/>
        </p:nvSpPr>
        <p:spPr>
          <a:xfrm>
            <a:off x="3995640" y="73627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TextBox 14"/>
          <p:cNvSpPr/>
          <p:nvPr/>
        </p:nvSpPr>
        <p:spPr>
          <a:xfrm>
            <a:off x="4356000" y="10174320"/>
            <a:ext cx="21211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TextBox 19"/>
          <p:cNvSpPr/>
          <p:nvPr/>
        </p:nvSpPr>
        <p:spPr>
          <a:xfrm rot="16200000">
            <a:off x="2545200" y="86842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Rectangle 23"/>
          <p:cNvSpPr/>
          <p:nvPr/>
        </p:nvSpPr>
        <p:spPr>
          <a:xfrm>
            <a:off x="611280" y="73627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TextBox 14"/>
          <p:cNvSpPr/>
          <p:nvPr/>
        </p:nvSpPr>
        <p:spPr>
          <a:xfrm>
            <a:off x="971640" y="10174320"/>
            <a:ext cx="212076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TextBox 25"/>
          <p:cNvSpPr/>
          <p:nvPr/>
        </p:nvSpPr>
        <p:spPr>
          <a:xfrm rot="16200000">
            <a:off x="-838800" y="86842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Rectangle 26"/>
          <p:cNvSpPr/>
          <p:nvPr/>
        </p:nvSpPr>
        <p:spPr>
          <a:xfrm>
            <a:off x="3995640" y="11365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TextBox 14"/>
          <p:cNvSpPr/>
          <p:nvPr/>
        </p:nvSpPr>
        <p:spPr>
          <a:xfrm>
            <a:off x="4356000" y="3948120"/>
            <a:ext cx="212112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TextBox 19"/>
          <p:cNvSpPr/>
          <p:nvPr/>
        </p:nvSpPr>
        <p:spPr>
          <a:xfrm rot="16200000">
            <a:off x="2545200" y="24580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Rectangle 29"/>
          <p:cNvSpPr/>
          <p:nvPr/>
        </p:nvSpPr>
        <p:spPr>
          <a:xfrm>
            <a:off x="611280" y="1136520"/>
            <a:ext cx="2808360" cy="36540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TextBox 14"/>
          <p:cNvSpPr/>
          <p:nvPr/>
        </p:nvSpPr>
        <p:spPr>
          <a:xfrm>
            <a:off x="971640" y="3948120"/>
            <a:ext cx="212076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log2(frequency ratio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TextBox 31"/>
          <p:cNvSpPr/>
          <p:nvPr/>
        </p:nvSpPr>
        <p:spPr>
          <a:xfrm rot="16200000">
            <a:off x="-838800" y="2458080"/>
            <a:ext cx="2494080" cy="291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MS PGothic"/>
              </a:rPr>
              <a:t>Difference in GC content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5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23T09:27:06Z</dcterms:created>
  <dc:creator>Alexis Vandenbon</dc:creator>
  <dc:description/>
  <dc:language>en-US</dc:language>
  <cp:lastModifiedBy>alexvdb</cp:lastModifiedBy>
  <dcterms:modified xsi:type="dcterms:W3CDTF">2012-03-21T13:17:50Z</dcterms:modified>
  <cp:revision>219</cp:revision>
  <dc:subject/>
  <dc:title>スライド 1</dc:title>
</cp:coreProperties>
</file>